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4" d="100"/>
          <a:sy n="84" d="100"/>
        </p:scale>
        <p:origin x="-72" y="-65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RNA-seq%20paper-(201210)\data-for%20figures\for%20figure-6-top%2010%20DEG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6.4262975192617269E-2"/>
          <c:y val="9.9398269660736865E-2"/>
          <c:w val="0.90616713233426449"/>
          <c:h val="0.86293185574025466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val>
            <c:numRef>
              <c:f>'top 10'!$E$90:$E$109</c:f>
              <c:numCache>
                <c:formatCode>General</c:formatCode>
                <c:ptCount val="20"/>
                <c:pt idx="0">
                  <c:v>4.0503351598597845</c:v>
                </c:pt>
                <c:pt idx="1">
                  <c:v>3.4939501365827867</c:v>
                </c:pt>
                <c:pt idx="2">
                  <c:v>3.3133750097282579</c:v>
                </c:pt>
                <c:pt idx="3">
                  <c:v>2.9914433021952394</c:v>
                </c:pt>
                <c:pt idx="4">
                  <c:v>2.8659054941233713</c:v>
                </c:pt>
                <c:pt idx="5">
                  <c:v>2.5764069714648765</c:v>
                </c:pt>
                <c:pt idx="6">
                  <c:v>2.5764064986903477</c:v>
                </c:pt>
                <c:pt idx="7">
                  <c:v>2.4064857948267977</c:v>
                </c:pt>
                <c:pt idx="8">
                  <c:v>2.4064857391323198</c:v>
                </c:pt>
                <c:pt idx="9">
                  <c:v>2.213834085026178</c:v>
                </c:pt>
                <c:pt idx="10">
                  <c:v>-2.7634438450000012</c:v>
                </c:pt>
                <c:pt idx="11">
                  <c:v>-2.915434678</c:v>
                </c:pt>
                <c:pt idx="12">
                  <c:v>-2.9154354789999988</c:v>
                </c:pt>
                <c:pt idx="13">
                  <c:v>-2.9154419319999967</c:v>
                </c:pt>
                <c:pt idx="14">
                  <c:v>-2.9720290089999999</c:v>
                </c:pt>
                <c:pt idx="15">
                  <c:v>-3.4008683529999999</c:v>
                </c:pt>
                <c:pt idx="16">
                  <c:v>-3.4008747810000002</c:v>
                </c:pt>
                <c:pt idx="17">
                  <c:v>-3.9858345900000001</c:v>
                </c:pt>
                <c:pt idx="18">
                  <c:v>-4.0529442819999835</c:v>
                </c:pt>
                <c:pt idx="19">
                  <c:v>-4.148104688999980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0270464"/>
        <c:axId val="100272000"/>
      </c:barChart>
      <c:catAx>
        <c:axId val="10027046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100272000"/>
        <c:crosses val="autoZero"/>
        <c:auto val="1"/>
        <c:lblAlgn val="ctr"/>
        <c:lblOffset val="1000"/>
        <c:noMultiLvlLbl val="0"/>
      </c:catAx>
      <c:valAx>
        <c:axId val="100272000"/>
        <c:scaling>
          <c:orientation val="minMax"/>
          <c:max val="5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100270464"/>
        <c:crosses val="autoZero"/>
        <c:crossBetween val="between"/>
        <c:majorUnit val="1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77ADD6B-E002-45F9-8991-E28907FCB404}" type="datetimeFigureOut">
              <a:rPr lang="en-US"/>
              <a:pPr>
                <a:defRPr/>
              </a:pPr>
              <a:t>3/1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89332DD-5C58-49C1-BE72-22ECA80E987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BCBCF35-5695-4B21-AA7D-6AD32CC45401}" type="datetimeFigureOut">
              <a:rPr lang="en-US"/>
              <a:pPr>
                <a:defRPr/>
              </a:pPr>
              <a:t>3/1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853F22D-7807-42B3-B60F-6845C9B09FE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581E5A0-C0FC-4280-B172-10F6345DA481}" type="datetimeFigureOut">
              <a:rPr lang="en-US"/>
              <a:pPr>
                <a:defRPr/>
              </a:pPr>
              <a:t>3/1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F8B42CA-A9F5-48CF-9CBF-08264FEF970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206634-9CB1-45BA-B771-6F69E0A9E3D9}" type="datetimeFigureOut">
              <a:rPr lang="en-US"/>
              <a:pPr>
                <a:defRPr/>
              </a:pPr>
              <a:t>3/1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E0DD228-AFCE-4472-BC8B-2453B40B714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53031B4-294B-4218-A435-53A04FAE3E6D}" type="datetimeFigureOut">
              <a:rPr lang="en-US"/>
              <a:pPr>
                <a:defRPr/>
              </a:pPr>
              <a:t>3/1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8C73FB5-7028-481F-808E-A9B95E4C419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2F140A0-176E-4276-B929-2F1B3DD18E18}" type="datetimeFigureOut">
              <a:rPr lang="en-US"/>
              <a:pPr>
                <a:defRPr/>
              </a:pPr>
              <a:t>3/14/2014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2D38027-5606-4391-9D01-621665EEBD1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55E362D-A4B1-4CC8-97F8-DA13B26FD22F}" type="datetimeFigureOut">
              <a:rPr lang="en-US"/>
              <a:pPr>
                <a:defRPr/>
              </a:pPr>
              <a:t>3/14/2014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C007314-2DA7-4740-A72F-814A8F36E4A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2D05DF7-98D1-4302-B55F-AE1387974596}" type="datetimeFigureOut">
              <a:rPr lang="en-US"/>
              <a:pPr>
                <a:defRPr/>
              </a:pPr>
              <a:t>3/14/2014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611F102-7D96-4B6D-AAD9-D6AE67E7388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ECC0AB5-DB8C-4C46-8345-E3E1BCF1A5B0}" type="datetimeFigureOut">
              <a:rPr lang="en-US"/>
              <a:pPr>
                <a:defRPr/>
              </a:pPr>
              <a:t>3/14/2014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E381D8B-E6A3-4794-999A-CD3D89AADC8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4C14098-2396-4E97-A628-BC3D230197C7}" type="datetimeFigureOut">
              <a:rPr lang="en-US"/>
              <a:pPr>
                <a:defRPr/>
              </a:pPr>
              <a:t>3/14/2014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59CD08A-A604-4D1E-8422-221A3C68F44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6B9D9EB-9B3A-4080-89F3-A8114EC57C81}" type="datetimeFigureOut">
              <a:rPr lang="en-US"/>
              <a:pPr>
                <a:defRPr/>
              </a:pPr>
              <a:t>3/14/2014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627639-2DF6-49F3-9631-2D639DF2DC3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7CFD952E-9CB1-4CAD-8B05-C0B9244283F5}" type="datetimeFigureOut">
              <a:rPr lang="en-US"/>
              <a:pPr>
                <a:defRPr/>
              </a:pPr>
              <a:t>3/1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1DB6AE0B-BBCE-4657-9884-6C339934935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hyperlink" Target="http://www.genome.jp/kegg-bin/show_pathway?135545076827067/ko00860.args" TargetMode="External"/><Relationship Id="rId3" Type="http://schemas.openxmlformats.org/officeDocument/2006/relationships/hyperlink" Target="http://www.genome.jp/kegg-bin/show_pathway?135460390025435/ko01100.args" TargetMode="External"/><Relationship Id="rId7" Type="http://schemas.openxmlformats.org/officeDocument/2006/relationships/hyperlink" Target="http://www.genome.jp/kegg-bin/show_pathway?135545076827067/ko00260.args" TargetMode="Externa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hyperlink" Target="http://www.genome.jp/kegg-bin/show_pathway?135545076827067/ko00564.args" TargetMode="External"/><Relationship Id="rId5" Type="http://schemas.openxmlformats.org/officeDocument/2006/relationships/hyperlink" Target="http://www.genome.jp/kegg-bin/show_pathway?135545076827067/ko01100.args" TargetMode="External"/><Relationship Id="rId4" Type="http://schemas.openxmlformats.org/officeDocument/2006/relationships/hyperlink" Target="http://www.genome.jp/kegg-bin/show_pathway?135545076827067/ko04910.args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3" name="Rectangle 6"/>
          <p:cNvSpPr>
            <a:spLocks noChangeArrowheads="1"/>
          </p:cNvSpPr>
          <p:nvPr/>
        </p:nvSpPr>
        <p:spPr bwMode="auto">
          <a:xfrm>
            <a:off x="533400" y="6324600"/>
            <a:ext cx="845820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200">
                <a:latin typeface="Times New Roman" pitchFamily="18" charset="0"/>
                <a:cs typeface="Times New Roman" pitchFamily="18" charset="0"/>
              </a:rPr>
              <a:t>.</a:t>
            </a:r>
            <a:endParaRPr lang="en-US" sz="120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314" name="Text Box 6"/>
          <p:cNvSpPr txBox="1">
            <a:spLocks noChangeArrowheads="1"/>
          </p:cNvSpPr>
          <p:nvPr/>
        </p:nvSpPr>
        <p:spPr bwMode="auto">
          <a:xfrm rot="-5400000">
            <a:off x="28576" y="995362"/>
            <a:ext cx="2514600" cy="523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400" b="1"/>
              <a:t>Log2(Expression of Resistant/Susceptible</a:t>
            </a:r>
          </a:p>
        </p:txBody>
      </p:sp>
      <p:graphicFrame>
        <p:nvGraphicFramePr>
          <p:cNvPr id="6" name="Chart 5"/>
          <p:cNvGraphicFramePr/>
          <p:nvPr/>
        </p:nvGraphicFramePr>
        <p:xfrm>
          <a:off x="1447800" y="-108864"/>
          <a:ext cx="6248400" cy="28955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3316" name="TextBox 7"/>
          <p:cNvSpPr txBox="1">
            <a:spLocks noChangeArrowheads="1"/>
          </p:cNvSpPr>
          <p:nvPr/>
        </p:nvSpPr>
        <p:spPr bwMode="auto">
          <a:xfrm>
            <a:off x="4191000" y="2339975"/>
            <a:ext cx="1524000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400" b="1"/>
              <a:t>Transcript</a:t>
            </a:r>
            <a:r>
              <a:rPr lang="en-US" altLang="zh-CN" sz="1400"/>
              <a:t> </a:t>
            </a:r>
            <a:r>
              <a:rPr lang="en-US" altLang="zh-CN" sz="1400" b="1"/>
              <a:t>ID</a:t>
            </a:r>
            <a:endParaRPr lang="zh-CN" altLang="en-US" sz="1400" b="1"/>
          </a:p>
        </p:txBody>
      </p:sp>
      <p:graphicFrame>
        <p:nvGraphicFramePr>
          <p:cNvPr id="13438" name="Group 126"/>
          <p:cNvGraphicFramePr>
            <a:graphicFrameLocks noGrp="1"/>
          </p:cNvGraphicFramePr>
          <p:nvPr/>
        </p:nvGraphicFramePr>
        <p:xfrm>
          <a:off x="381000" y="2743200"/>
          <a:ext cx="8458200" cy="4043943"/>
        </p:xfrm>
        <a:graphic>
          <a:graphicData uri="http://schemas.openxmlformats.org/drawingml/2006/table">
            <a:tbl>
              <a:tblPr/>
              <a:tblGrid>
                <a:gridCol w="685800"/>
                <a:gridCol w="533400"/>
                <a:gridCol w="1085850"/>
                <a:gridCol w="1928813"/>
                <a:gridCol w="719137"/>
                <a:gridCol w="609600"/>
                <a:gridCol w="1066800"/>
                <a:gridCol w="1828800"/>
              </a:tblGrid>
              <a:tr h="285750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Transcript ID</a:t>
                      </a:r>
                    </a:p>
                  </a:txBody>
                  <a:tcPr marL="6783" marR="6783" marT="6783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KO number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KO Pathway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KO annotation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Transcript ID</a:t>
                      </a:r>
                    </a:p>
                  </a:txBody>
                  <a:tcPr marL="6783" marR="6783" marT="6783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KO number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KO Pathway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KO annotation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12738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</a:t>
                      </a:r>
                    </a:p>
                  </a:txBody>
                  <a:tcPr marL="6783" marR="6783" marT="6783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K02133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Metabolic pathways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ATPeF1B; F-type H+-transporting ATPase subunit beta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1</a:t>
                      </a:r>
                    </a:p>
                  </a:txBody>
                  <a:tcPr marL="6783" marR="6783" marT="6783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K03252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RNA transport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EIF3C; translation initiation factor 3 subunit C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12738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2</a:t>
                      </a:r>
                    </a:p>
                  </a:txBody>
                  <a:tcPr marL="6783" marR="6783" marT="6783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K00121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Metabolic pathways</a:t>
                      </a: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  <a:hlinkClick r:id="rId3"/>
                        </a:rPr>
                        <a:t> 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cs typeface="Arial" charset="0"/>
                      </a:endParaRP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Glutathione dehydrogenase / alcohol dehydrogenase 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2</a:t>
                      </a:r>
                    </a:p>
                  </a:txBody>
                  <a:tcPr marL="6783" marR="6783" marT="6783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K05402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Toll-like receptor signaling pathway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TOLLIP; toll-interacting protein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12738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3</a:t>
                      </a:r>
                    </a:p>
                  </a:txBody>
                  <a:tcPr marL="6783" marR="6783" marT="6783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K01889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Aminoacyl-tRNA biosynthesis 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FARSA; phenylalanyl-tRNA synthetase alpha chain 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3</a:t>
                      </a:r>
                    </a:p>
                  </a:txBody>
                  <a:tcPr marL="6783" marR="6783" marT="6783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K07207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Insulin signaling pathway </a:t>
                      </a: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  <a:hlinkClick r:id="rId4"/>
                        </a:rPr>
                        <a:t> 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cs typeface="Arial" charset="0"/>
                      </a:endParaRP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TSC2; tuberous sclerosis 2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12738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4</a:t>
                      </a:r>
                    </a:p>
                  </a:txBody>
                  <a:tcPr marL="6783" marR="6783" marT="6783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K00453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Metabolic pathways</a:t>
                      </a: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  <a:hlinkClick r:id="rId3"/>
                        </a:rPr>
                        <a:t>  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cs typeface="Arial" charset="0"/>
                      </a:endParaRP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E1.13.11.11; tryptophan 2,3-dioxygenase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4</a:t>
                      </a:r>
                    </a:p>
                  </a:txBody>
                  <a:tcPr marL="6783" marR="6783" marT="6783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K03017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Metabolic pathways</a:t>
                      </a: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  <a:hlinkClick r:id="rId5"/>
                        </a:rPr>
                        <a:t> 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cs typeface="Arial" charset="0"/>
                      </a:endParaRP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RPB9; DNA-directed RNA polymerase II subunit RPB9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12738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5</a:t>
                      </a:r>
                    </a:p>
                  </a:txBody>
                  <a:tcPr marL="6783" marR="6783" marT="6783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K00382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Metabolic pathways</a:t>
                      </a: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  <a:hlinkClick r:id="rId3"/>
                        </a:rPr>
                        <a:t> 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cs typeface="Arial" charset="0"/>
                      </a:endParaRP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DLD; dihydrolipoamide dehydrogenase 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5</a:t>
                      </a:r>
                    </a:p>
                  </a:txBody>
                  <a:tcPr marL="6783" marR="6783" marT="6783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K07936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RNA transport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RAN; GTP-binding nuclear protein Ran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12738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6</a:t>
                      </a:r>
                    </a:p>
                  </a:txBody>
                  <a:tcPr marL="6783" marR="6783" marT="6783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K00799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Glutathione metabolism  </a:t>
                      </a:r>
                    </a:p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cs typeface="Arial" charset="0"/>
                      </a:endParaRP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GST; glutathione S-transferase 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6</a:t>
                      </a:r>
                    </a:p>
                  </a:txBody>
                  <a:tcPr marL="6783" marR="6783" marT="6783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K06129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Glycerophospholipid metabolism </a:t>
                      </a: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  <a:hlinkClick r:id="rId6"/>
                        </a:rPr>
                        <a:t> 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cs typeface="Arial" charset="0"/>
                      </a:endParaRP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LYPLA3; lysophospholipase III [EC:3.1.1.5]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12738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7</a:t>
                      </a:r>
                    </a:p>
                  </a:txBody>
                  <a:tcPr marL="6783" marR="6783" marT="6783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K07511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Metabolic pathways</a:t>
                      </a: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  <a:hlinkClick r:id="rId3"/>
                        </a:rPr>
                        <a:t> 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cs typeface="Arial" charset="0"/>
                      </a:endParaRP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ECHS1; enoyl-CoA hydratase 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7</a:t>
                      </a:r>
                    </a:p>
                  </a:txBody>
                  <a:tcPr marL="6783" marR="6783" marT="6783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K00857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Metabolic pathways</a:t>
                      </a: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  <a:hlinkClick r:id="rId5"/>
                        </a:rPr>
                        <a:t> 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cs typeface="Arial" charset="0"/>
                      </a:endParaRP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E2.7.1.21; thymidine kinase [EC:2.7.1.21]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46075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8</a:t>
                      </a:r>
                    </a:p>
                  </a:txBody>
                  <a:tcPr marL="6783" marR="6783" marT="6783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K03942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Metabolic pathways</a:t>
                      </a: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  <a:hlinkClick r:id="rId3"/>
                        </a:rPr>
                        <a:t> 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cs typeface="Arial" charset="0"/>
                      </a:endParaRP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NDUFV1; NADH dehydrogenase (ubiquinone) flavoprotein 1 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8</a:t>
                      </a:r>
                    </a:p>
                  </a:txBody>
                  <a:tcPr marL="6783" marR="6783" marT="6783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K00639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Glycine, serine and threonine metabolism </a:t>
                      </a: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  <a:hlinkClick r:id="rId7"/>
                        </a:rPr>
                        <a:t> 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cs typeface="Arial" charset="0"/>
                      </a:endParaRP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kbl; glycine C-acetyltransferase [EC:2.3.1.29]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81000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9</a:t>
                      </a:r>
                    </a:p>
                  </a:txBody>
                  <a:tcPr marL="6783" marR="6783" marT="6783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K02264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Metabolic pathways</a:t>
                      </a: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  <a:hlinkClick r:id="rId3"/>
                        </a:rPr>
                        <a:t> 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cs typeface="Arial" charset="0"/>
                      </a:endParaRP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COX5A; cytochrome c oxidase subunit 5a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9</a:t>
                      </a:r>
                    </a:p>
                  </a:txBody>
                  <a:tcPr marL="6783" marR="6783" marT="6783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K00522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Porphyrin and chlorophyll metabolism </a:t>
                      </a: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  <a:hlinkClick r:id="rId8"/>
                        </a:rPr>
                        <a:t> 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cs typeface="Arial" charset="0"/>
                      </a:endParaRP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FTH1; ferritin heavy chain [EC:1.16.3.1]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22263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0</a:t>
                      </a:r>
                    </a:p>
                  </a:txBody>
                  <a:tcPr marL="6783" marR="6783" marT="6783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K00688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Metabolic pathways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E2.4.1.1; starch phosphorylase 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20</a:t>
                      </a:r>
                    </a:p>
                  </a:txBody>
                  <a:tcPr marL="6783" marR="6783" marT="6783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K04353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MAPK signaling pathway </a:t>
                      </a:r>
                    </a:p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cs typeface="Arial" charset="0"/>
                      </a:endParaRP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RAP1A; Ras-related protein Rap-1A</a:t>
                      </a:r>
                    </a:p>
                  </a:txBody>
                  <a:tcPr marL="6783" marR="6783" marT="6783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7" name="Rectangle 6"/>
          <p:cNvSpPr/>
          <p:nvPr/>
        </p:nvSpPr>
        <p:spPr>
          <a:xfrm>
            <a:off x="7266563" y="0"/>
            <a:ext cx="18774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Additional_file_5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6</TotalTime>
  <Words>234</Words>
  <Application>Microsoft Office PowerPoint</Application>
  <PresentationFormat>On-screen Show (4:3)</PresentationFormat>
  <Paragraphs>9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 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Zhong, Daibin</dc:creator>
  <cp:lastModifiedBy>Zhong, Daibin</cp:lastModifiedBy>
  <cp:revision>28</cp:revision>
  <dcterms:created xsi:type="dcterms:W3CDTF">2013-01-04T22:42:34Z</dcterms:created>
  <dcterms:modified xsi:type="dcterms:W3CDTF">2014-03-14T13:22:50Z</dcterms:modified>
</cp:coreProperties>
</file>